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1" r:id="rId3"/>
    <p:sldId id="262" r:id="rId4"/>
    <p:sldId id="257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CC1490-E408-40D5-9F6D-0BCDF204A8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B4F30C-447D-4BC5-80F5-BFF1A1BE43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429ED5-C82C-4DF4-B5E5-934C05B78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844609-6035-484A-BB93-B29B4E927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DE8763-7181-4AD7-87E9-6D5A2C9BF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739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7EC12-C138-46CC-967E-3F0D0329B0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CDE18A-2892-475C-A736-BCEA197959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817E99-EE71-46BA-9CA9-B3FB206EA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DE5B9F-5C98-4592-BC0B-8F96E053E5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46ABE6-903E-4F7C-BEEF-4BC84C0BA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861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35661A-A9CA-4183-9C28-ACB7606410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74E7CC-6B2F-483C-B1C4-96B9EBE420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1FB21A-9E31-45A8-9D0B-5C906F141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60180E-3C4F-4FF9-B8ED-597C4801B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F883D2-7097-42ED-9C1E-9F5B0B686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063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DCC70B-5BDC-4D60-848E-6848143F17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3B84C0-21D8-46D2-B5E2-4D89BF9B51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B28D33-372D-44F8-94CF-F0743433D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CFD24-E2EA-4907-BE61-78E050D1A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3BB7C1-753A-4440-9F0C-F0CF32DE7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058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837BF-499B-4840-BFDA-C5A5BF6BA2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DD1B24-FC68-4D88-9E2A-4E1E4F5A9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FCB972-6900-4F11-B1D5-4172C5574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2FE85-D6F1-4DDB-859A-31422B3E5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8BEBFB-4037-49B3-8040-1F7601DA4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890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F5227-CC8B-4C45-8656-0342CDBDD8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93B7FD-BEC9-4522-B917-1E35135D71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57AD28-8797-4DFD-8074-ABEF0F74EB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45E8D8-F8BC-45DE-A9D3-414AD9AFD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2A2DB0-3039-4957-9580-4AB2378D6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471945-23FE-441D-BD2C-5150A20B6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965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4E84D5-4A3C-42EF-98E3-D43DDFD01D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EB32F2-A480-44A6-90E8-8E7D7778D2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29E3DB-48EF-4AA5-ACD3-47F565E280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0A5F702-C429-4965-BCFC-16EC234D8A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C171E8C-D5BD-4CB0-9682-C22DB8FB54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6B5153-BAED-4CA5-8BAF-65956AF35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DFEC7D-0D5B-45DC-8D63-D87947BFD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70B1FA-B5C8-4D9F-BB96-718D59968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369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952B6C-B85F-47A6-B379-71F2606E7C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A065B9-90E0-40E1-947B-2C741CD5E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477356A-4296-46AB-96BB-E28766044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50FD4F-3DAF-4236-9E5E-6226E6203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535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EDB960-616A-4BC7-8231-718E76555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ED45D3-583B-4414-97CC-82BC61B0D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64A462-5A1F-4310-BCEE-7D17ADE3CB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660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201846-BCA4-4BC9-929D-C2EC6193FF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736BDC-F1D7-49FB-B118-5F401096B0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B56429-5F24-4520-BCB6-DB3D3360DD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078E74-BD0B-448C-8878-239C521ED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EE0F06-042A-440A-99DE-8A428DC67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ABD5B6-EFE5-42AD-A904-2AB0E652C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300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5D3DD9-6EE8-4B04-9CD6-5198DE1F75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FF6E9F-6FEF-4E11-8EE9-87ACE7E102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84D48C-95E4-4200-BCDC-E2C5906A6D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4F6792-0EBF-4B42-9E03-D39CDA49EB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2BDB04-025F-4A5E-8E2C-A09AAF3A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D0252D-A82F-487A-8803-262F586DE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127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EE2F15-DC29-43E9-BDC2-CB1FAC507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848C44-104A-4B07-BA5E-47C2CB7C61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090E60-2937-469C-A597-E12E631B78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8B2607-7E0F-4F83-A522-DC6C06D99E62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35BDBF-E05E-4C72-9CBF-171C262146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5A2CC0-306A-4956-AE11-04CBD53FD4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D97BE8-177B-41DA-AEBE-5E460817EB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579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>
            <a:extLst>
              <a:ext uri="{FF2B5EF4-FFF2-40B4-BE49-F238E27FC236}">
                <a16:creationId xmlns:a16="http://schemas.microsoft.com/office/drawing/2014/main" id="{6D09210C-D197-4362-953F-0C11561957A9}"/>
              </a:ext>
            </a:extLst>
          </p:cNvPr>
          <p:cNvGrpSpPr/>
          <p:nvPr/>
        </p:nvGrpSpPr>
        <p:grpSpPr>
          <a:xfrm>
            <a:off x="444500" y="361950"/>
            <a:ext cx="11706222" cy="2765425"/>
            <a:chOff x="444500" y="361950"/>
            <a:chExt cx="11706222" cy="2765425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EF1CC1EC-DE4E-42B0-937F-EB47D24E6F9B}"/>
                </a:ext>
              </a:extLst>
            </p:cNvPr>
            <p:cNvSpPr/>
            <p:nvPr/>
          </p:nvSpPr>
          <p:spPr>
            <a:xfrm>
              <a:off x="444500" y="1419225"/>
              <a:ext cx="2387600" cy="46990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dirty="0">
                  <a:solidFill>
                    <a:schemeClr val="tx1"/>
                  </a:solidFill>
                </a:rPr>
                <a:t>Cleaning quart tube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6B1E07D4-1F85-4FC6-BA15-4BDA076F015F}"/>
                </a:ext>
              </a:extLst>
            </p:cNvPr>
            <p:cNvSpPr/>
            <p:nvPr/>
          </p:nvSpPr>
          <p:spPr>
            <a:xfrm>
              <a:off x="444500" y="2505075"/>
              <a:ext cx="2387600" cy="62230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dirty="0">
                  <a:solidFill>
                    <a:schemeClr val="tx1"/>
                  </a:solidFill>
                </a:rPr>
                <a:t>One-end sealing quart tube</a:t>
              </a:r>
            </a:p>
          </p:txBody>
        </p:sp>
        <p:sp>
          <p:nvSpPr>
            <p:cNvPr id="7" name="Rectangle: Rounded Corners 6">
              <a:extLst>
                <a:ext uri="{FF2B5EF4-FFF2-40B4-BE49-F238E27FC236}">
                  <a16:creationId xmlns:a16="http://schemas.microsoft.com/office/drawing/2014/main" id="{271B5C88-FBE1-46B2-802F-E46495557B01}"/>
                </a:ext>
              </a:extLst>
            </p:cNvPr>
            <p:cNvSpPr/>
            <p:nvPr/>
          </p:nvSpPr>
          <p:spPr>
            <a:xfrm>
              <a:off x="444500" y="361950"/>
              <a:ext cx="2387600" cy="692150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dirty="0">
                  <a:solidFill>
                    <a:schemeClr val="tx1"/>
                  </a:solidFill>
                </a:rPr>
                <a:t>Measuring materials weight</a:t>
              </a:r>
            </a:p>
          </p:txBody>
        </p:sp>
        <p:sp>
          <p:nvSpPr>
            <p:cNvPr id="8" name="Rectangle: Rounded Corners 7">
              <a:extLst>
                <a:ext uri="{FF2B5EF4-FFF2-40B4-BE49-F238E27FC236}">
                  <a16:creationId xmlns:a16="http://schemas.microsoft.com/office/drawing/2014/main" id="{6FC96453-7320-4B7E-BFE3-80D43D0AAFFB}"/>
                </a:ext>
              </a:extLst>
            </p:cNvPr>
            <p:cNvSpPr/>
            <p:nvPr/>
          </p:nvSpPr>
          <p:spPr>
            <a:xfrm>
              <a:off x="3590926" y="361950"/>
              <a:ext cx="2387600" cy="2765425"/>
            </a:xfrm>
            <a:prstGeom prst="roundRect">
              <a:avLst>
                <a:gd name="adj" fmla="val 0"/>
              </a:avLst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dirty="0">
                  <a:solidFill>
                    <a:schemeClr val="tx1"/>
                  </a:solidFill>
                </a:rPr>
                <a:t>Pouring materials into quart tube</a:t>
              </a:r>
            </a:p>
          </p:txBody>
        </p:sp>
        <p:sp>
          <p:nvSpPr>
            <p:cNvPr id="9" name="Rectangle: Rounded Corners 8">
              <a:extLst>
                <a:ext uri="{FF2B5EF4-FFF2-40B4-BE49-F238E27FC236}">
                  <a16:creationId xmlns:a16="http://schemas.microsoft.com/office/drawing/2014/main" id="{B0E4299F-BF11-4679-A9B0-B4AF2E7BBD85}"/>
                </a:ext>
              </a:extLst>
            </p:cNvPr>
            <p:cNvSpPr/>
            <p:nvPr/>
          </p:nvSpPr>
          <p:spPr>
            <a:xfrm>
              <a:off x="9763122" y="2492374"/>
              <a:ext cx="2387600" cy="622300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dirty="0">
                  <a:solidFill>
                    <a:schemeClr val="tx1"/>
                  </a:solidFill>
                </a:rPr>
                <a:t>Diameter measuring by using SEM image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E7EC72A9-EEB4-434B-BA97-FB6C858BD2ED}"/>
                </a:ext>
              </a:extLst>
            </p:cNvPr>
            <p:cNvSpPr/>
            <p:nvPr/>
          </p:nvSpPr>
          <p:spPr>
            <a:xfrm>
              <a:off x="6677024" y="527050"/>
              <a:ext cx="2387600" cy="62230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dirty="0">
                  <a:solidFill>
                    <a:schemeClr val="tx1"/>
                  </a:solidFill>
                </a:rPr>
                <a:t>Releasing pollutant by Vacuum process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5EB4E88A-D5AE-49BE-97E2-DFAD9E34826F}"/>
                </a:ext>
              </a:extLst>
            </p:cNvPr>
            <p:cNvSpPr/>
            <p:nvPr/>
          </p:nvSpPr>
          <p:spPr>
            <a:xfrm>
              <a:off x="6677024" y="1727200"/>
              <a:ext cx="2387600" cy="62230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dirty="0">
                  <a:solidFill>
                    <a:schemeClr val="tx1"/>
                  </a:solidFill>
                </a:rPr>
                <a:t>Both-end sealing quart tube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5FE0896C-FC16-481C-958D-1C7AD2C1469F}"/>
                </a:ext>
              </a:extLst>
            </p:cNvPr>
            <p:cNvSpPr/>
            <p:nvPr/>
          </p:nvSpPr>
          <p:spPr>
            <a:xfrm>
              <a:off x="9763122" y="1263650"/>
              <a:ext cx="2387600" cy="62230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dirty="0">
                  <a:solidFill>
                    <a:schemeClr val="tx1"/>
                  </a:solidFill>
                </a:rPr>
                <a:t>Baking process</a:t>
              </a:r>
            </a:p>
          </p:txBody>
        </p:sp>
        <p:sp>
          <p:nvSpPr>
            <p:cNvPr id="13" name="Arrow: Down 12">
              <a:extLst>
                <a:ext uri="{FF2B5EF4-FFF2-40B4-BE49-F238E27FC236}">
                  <a16:creationId xmlns:a16="http://schemas.microsoft.com/office/drawing/2014/main" id="{1E09FBFD-DAFE-4B73-8B17-1EBF18D0543B}"/>
                </a:ext>
              </a:extLst>
            </p:cNvPr>
            <p:cNvSpPr/>
            <p:nvPr/>
          </p:nvSpPr>
          <p:spPr>
            <a:xfrm>
              <a:off x="1517650" y="1965325"/>
              <a:ext cx="241300" cy="463550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Arrow: Down 13">
              <a:extLst>
                <a:ext uri="{FF2B5EF4-FFF2-40B4-BE49-F238E27FC236}">
                  <a16:creationId xmlns:a16="http://schemas.microsoft.com/office/drawing/2014/main" id="{2CCDFCCC-DAA9-483C-A735-5ABD39F8E785}"/>
                </a:ext>
              </a:extLst>
            </p:cNvPr>
            <p:cNvSpPr/>
            <p:nvPr/>
          </p:nvSpPr>
          <p:spPr>
            <a:xfrm rot="16200000">
              <a:off x="3130550" y="365125"/>
              <a:ext cx="241300" cy="463550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Arrow: Down 26">
              <a:extLst>
                <a:ext uri="{FF2B5EF4-FFF2-40B4-BE49-F238E27FC236}">
                  <a16:creationId xmlns:a16="http://schemas.microsoft.com/office/drawing/2014/main" id="{E3E4A2D1-D4CE-468F-9002-DD86C781980C}"/>
                </a:ext>
              </a:extLst>
            </p:cNvPr>
            <p:cNvSpPr/>
            <p:nvPr/>
          </p:nvSpPr>
          <p:spPr>
            <a:xfrm rot="16200000">
              <a:off x="3090863" y="2584450"/>
              <a:ext cx="241300" cy="463550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Arrow: Down 27">
              <a:extLst>
                <a:ext uri="{FF2B5EF4-FFF2-40B4-BE49-F238E27FC236}">
                  <a16:creationId xmlns:a16="http://schemas.microsoft.com/office/drawing/2014/main" id="{FEB423D5-E2C1-4504-8FC8-946AEDE010CF}"/>
                </a:ext>
              </a:extLst>
            </p:cNvPr>
            <p:cNvSpPr/>
            <p:nvPr/>
          </p:nvSpPr>
          <p:spPr>
            <a:xfrm rot="16200000">
              <a:off x="6207125" y="606425"/>
              <a:ext cx="241300" cy="463550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Arrow: Down 28">
              <a:extLst>
                <a:ext uri="{FF2B5EF4-FFF2-40B4-BE49-F238E27FC236}">
                  <a16:creationId xmlns:a16="http://schemas.microsoft.com/office/drawing/2014/main" id="{5D85D82E-0CAF-4B3D-BE65-8E33788AFB31}"/>
                </a:ext>
              </a:extLst>
            </p:cNvPr>
            <p:cNvSpPr/>
            <p:nvPr/>
          </p:nvSpPr>
          <p:spPr>
            <a:xfrm>
              <a:off x="7750174" y="1201738"/>
              <a:ext cx="241300" cy="463550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Arrow: Down 29">
              <a:extLst>
                <a:ext uri="{FF2B5EF4-FFF2-40B4-BE49-F238E27FC236}">
                  <a16:creationId xmlns:a16="http://schemas.microsoft.com/office/drawing/2014/main" id="{D885557D-6C45-4106-83E2-445736917BBF}"/>
                </a:ext>
              </a:extLst>
            </p:cNvPr>
            <p:cNvSpPr/>
            <p:nvPr/>
          </p:nvSpPr>
          <p:spPr>
            <a:xfrm rot="14348707">
              <a:off x="9308099" y="1644844"/>
              <a:ext cx="241300" cy="463550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Arrow: Down 30">
              <a:extLst>
                <a:ext uri="{FF2B5EF4-FFF2-40B4-BE49-F238E27FC236}">
                  <a16:creationId xmlns:a16="http://schemas.microsoft.com/office/drawing/2014/main" id="{F924CA97-4D69-42E5-B931-56409AB20050}"/>
                </a:ext>
              </a:extLst>
            </p:cNvPr>
            <p:cNvSpPr/>
            <p:nvPr/>
          </p:nvSpPr>
          <p:spPr>
            <a:xfrm>
              <a:off x="10836272" y="1956188"/>
              <a:ext cx="241300" cy="463550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4" name="Rectangle 33">
            <a:extLst>
              <a:ext uri="{FF2B5EF4-FFF2-40B4-BE49-F238E27FC236}">
                <a16:creationId xmlns:a16="http://schemas.microsoft.com/office/drawing/2014/main" id="{1D35179F-1D7B-484B-9F2C-08C337529A10}"/>
              </a:ext>
            </a:extLst>
          </p:cNvPr>
          <p:cNvSpPr/>
          <p:nvPr/>
        </p:nvSpPr>
        <p:spPr>
          <a:xfrm>
            <a:off x="3124286" y="4077087"/>
            <a:ext cx="7105475" cy="10821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i="1" dirty="0"/>
              <a:t>Fig. 1 HVPG technique flowchart to synthesis Ag/TiO</a:t>
            </a:r>
            <a:r>
              <a:rPr lang="en-US" i="1" baseline="-25000" dirty="0"/>
              <a:t>2</a:t>
            </a:r>
            <a:r>
              <a:rPr lang="en-US" i="1" dirty="0"/>
              <a:t> nanocomposite materials</a:t>
            </a:r>
          </a:p>
        </p:txBody>
      </p:sp>
    </p:spTree>
    <p:extLst>
      <p:ext uri="{BB962C8B-B14F-4D97-AF65-F5344CB8AC3E}">
        <p14:creationId xmlns:p14="http://schemas.microsoft.com/office/powerpoint/2010/main" val="33483479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761A6E03-6C80-4586-BE52-2A66D5CF9ACC}"/>
              </a:ext>
            </a:extLst>
          </p:cNvPr>
          <p:cNvGrpSpPr/>
          <p:nvPr/>
        </p:nvGrpSpPr>
        <p:grpSpPr>
          <a:xfrm>
            <a:off x="2667000" y="209550"/>
            <a:ext cx="6858000" cy="5143500"/>
            <a:chOff x="2667000" y="857250"/>
            <a:chExt cx="6858000" cy="5143500"/>
          </a:xfrm>
        </p:grpSpPr>
        <p:pic>
          <p:nvPicPr>
            <p:cNvPr id="5" name="Picture 4" descr="A picture containing oven, indoor, car, sitting&#10;&#10;Description automatically generated">
              <a:extLst>
                <a:ext uri="{FF2B5EF4-FFF2-40B4-BE49-F238E27FC236}">
                  <a16:creationId xmlns:a16="http://schemas.microsoft.com/office/drawing/2014/main" id="{997A3FD8-E040-4DC9-8B4D-585E3BA2CA6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7000" y="857250"/>
              <a:ext cx="6858000" cy="5143500"/>
            </a:xfrm>
            <a:prstGeom prst="rect">
              <a:avLst/>
            </a:prstGeom>
          </p:spPr>
        </p:pic>
        <p:sp>
          <p:nvSpPr>
            <p:cNvPr id="6" name="Rectangle: Rounded Corners 5">
              <a:extLst>
                <a:ext uri="{FF2B5EF4-FFF2-40B4-BE49-F238E27FC236}">
                  <a16:creationId xmlns:a16="http://schemas.microsoft.com/office/drawing/2014/main" id="{83FA247C-805D-4F53-887E-8D4FAAAE04E3}"/>
                </a:ext>
              </a:extLst>
            </p:cNvPr>
            <p:cNvSpPr/>
            <p:nvPr/>
          </p:nvSpPr>
          <p:spPr>
            <a:xfrm>
              <a:off x="3406140" y="2331720"/>
              <a:ext cx="5623560" cy="1097280"/>
            </a:xfrm>
            <a:prstGeom prst="roundRect">
              <a:avLst/>
            </a:prstGeom>
            <a:solidFill>
              <a:srgbClr val="FF0000">
                <a:alpha val="15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: Rounded Corners 14">
              <a:extLst>
                <a:ext uri="{FF2B5EF4-FFF2-40B4-BE49-F238E27FC236}">
                  <a16:creationId xmlns:a16="http://schemas.microsoft.com/office/drawing/2014/main" id="{D9F42FF5-8BAA-497B-854F-0A06D2D611B8}"/>
                </a:ext>
              </a:extLst>
            </p:cNvPr>
            <p:cNvSpPr/>
            <p:nvPr/>
          </p:nvSpPr>
          <p:spPr>
            <a:xfrm>
              <a:off x="4884420" y="1866900"/>
              <a:ext cx="2667000" cy="46482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Quartz tube from heater</a:t>
              </a:r>
            </a:p>
          </p:txBody>
        </p:sp>
      </p:grpSp>
      <p:sp>
        <p:nvSpPr>
          <p:cNvPr id="23" name="Rectangle 22">
            <a:extLst>
              <a:ext uri="{FF2B5EF4-FFF2-40B4-BE49-F238E27FC236}">
                <a16:creationId xmlns:a16="http://schemas.microsoft.com/office/drawing/2014/main" id="{38C3CE9B-F7BF-4E91-9928-15ED5A6599F5}"/>
              </a:ext>
            </a:extLst>
          </p:cNvPr>
          <p:cNvSpPr/>
          <p:nvPr/>
        </p:nvSpPr>
        <p:spPr>
          <a:xfrm>
            <a:off x="2543262" y="5577700"/>
            <a:ext cx="7105475" cy="10821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i="1" dirty="0"/>
              <a:t>Fig. 2 Quartz tube used for synthesis Ag/TiO</a:t>
            </a:r>
            <a:r>
              <a:rPr lang="en-US" i="1" baseline="-25000" dirty="0"/>
              <a:t>2</a:t>
            </a:r>
            <a:r>
              <a:rPr lang="en-US" i="1" dirty="0"/>
              <a:t> nanocomposite material</a:t>
            </a:r>
          </a:p>
        </p:txBody>
      </p:sp>
    </p:spTree>
    <p:extLst>
      <p:ext uri="{BB962C8B-B14F-4D97-AF65-F5344CB8AC3E}">
        <p14:creationId xmlns:p14="http://schemas.microsoft.com/office/powerpoint/2010/main" val="1520945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A8DE72A5-DD22-423E-B7CD-2184A3934DE0}"/>
              </a:ext>
            </a:extLst>
          </p:cNvPr>
          <p:cNvGrpSpPr/>
          <p:nvPr/>
        </p:nvGrpSpPr>
        <p:grpSpPr>
          <a:xfrm>
            <a:off x="3651609" y="695952"/>
            <a:ext cx="4888782" cy="3320276"/>
            <a:chOff x="4162425" y="1915152"/>
            <a:chExt cx="4888782" cy="3320276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6A77E7E2-6A15-4910-A564-62839DC861BF}"/>
                </a:ext>
              </a:extLst>
            </p:cNvPr>
            <p:cNvSpPr/>
            <p:nvPr/>
          </p:nvSpPr>
          <p:spPr>
            <a:xfrm>
              <a:off x="4562475" y="2257425"/>
              <a:ext cx="4143375" cy="264795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>
              <a:extLst>
                <a:ext uri="{FF2B5EF4-FFF2-40B4-BE49-F238E27FC236}">
                  <a16:creationId xmlns:a16="http://schemas.microsoft.com/office/drawing/2014/main" id="{5CDB9387-C7B1-4F46-9BB1-7BE7EB12CCB6}"/>
                </a:ext>
              </a:extLst>
            </p:cNvPr>
            <p:cNvSpPr/>
            <p:nvPr/>
          </p:nvSpPr>
          <p:spPr>
            <a:xfrm>
              <a:off x="5172075" y="2733675"/>
              <a:ext cx="533400" cy="200025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0698EE1E-FFD5-4519-8BF5-15DF36D71838}"/>
                </a:ext>
              </a:extLst>
            </p:cNvPr>
            <p:cNvSpPr/>
            <p:nvPr/>
          </p:nvSpPr>
          <p:spPr>
            <a:xfrm>
              <a:off x="6438900" y="3228975"/>
              <a:ext cx="323850" cy="200025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: Rounded Corners 7">
              <a:extLst>
                <a:ext uri="{FF2B5EF4-FFF2-40B4-BE49-F238E27FC236}">
                  <a16:creationId xmlns:a16="http://schemas.microsoft.com/office/drawing/2014/main" id="{DF7E98AF-80B2-4A75-B8E5-71D4CD9B39D6}"/>
                </a:ext>
              </a:extLst>
            </p:cNvPr>
            <p:cNvSpPr/>
            <p:nvPr/>
          </p:nvSpPr>
          <p:spPr>
            <a:xfrm rot="2652975">
              <a:off x="7248525" y="3067050"/>
              <a:ext cx="904875" cy="161925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: Rounded Corners 8">
              <a:extLst>
                <a:ext uri="{FF2B5EF4-FFF2-40B4-BE49-F238E27FC236}">
                  <a16:creationId xmlns:a16="http://schemas.microsoft.com/office/drawing/2014/main" id="{B6324D19-3F9C-46F5-BC03-A5C1008D43FA}"/>
                </a:ext>
              </a:extLst>
            </p:cNvPr>
            <p:cNvSpPr/>
            <p:nvPr/>
          </p:nvSpPr>
          <p:spPr>
            <a:xfrm rot="20606724">
              <a:off x="8096251" y="3893030"/>
              <a:ext cx="904875" cy="161925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Chord 9">
              <a:extLst>
                <a:ext uri="{FF2B5EF4-FFF2-40B4-BE49-F238E27FC236}">
                  <a16:creationId xmlns:a16="http://schemas.microsoft.com/office/drawing/2014/main" id="{B2715696-5925-48D5-8EE0-3609F1FF472B}"/>
                </a:ext>
              </a:extLst>
            </p:cNvPr>
            <p:cNvSpPr/>
            <p:nvPr/>
          </p:nvSpPr>
          <p:spPr>
            <a:xfrm>
              <a:off x="5505450" y="3990975"/>
              <a:ext cx="333375" cy="285750"/>
            </a:xfrm>
            <a:prstGeom prst="chord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Chord 10">
              <a:extLst>
                <a:ext uri="{FF2B5EF4-FFF2-40B4-BE49-F238E27FC236}">
                  <a16:creationId xmlns:a16="http://schemas.microsoft.com/office/drawing/2014/main" id="{280667DA-1A33-4BA1-B9E3-642951062CE8}"/>
                </a:ext>
              </a:extLst>
            </p:cNvPr>
            <p:cNvSpPr/>
            <p:nvPr/>
          </p:nvSpPr>
          <p:spPr>
            <a:xfrm>
              <a:off x="6632005" y="4152900"/>
              <a:ext cx="333375" cy="285750"/>
            </a:xfrm>
            <a:prstGeom prst="chord">
              <a:avLst>
                <a:gd name="adj1" fmla="val 8708964"/>
                <a:gd name="adj2" fmla="val 16200000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: Rounded Corners 11">
              <a:extLst>
                <a:ext uri="{FF2B5EF4-FFF2-40B4-BE49-F238E27FC236}">
                  <a16:creationId xmlns:a16="http://schemas.microsoft.com/office/drawing/2014/main" id="{6575C814-308F-4D45-AE20-4F80CAB6E059}"/>
                </a:ext>
              </a:extLst>
            </p:cNvPr>
            <p:cNvSpPr/>
            <p:nvPr/>
          </p:nvSpPr>
          <p:spPr>
            <a:xfrm rot="2652975">
              <a:off x="5767116" y="1915152"/>
              <a:ext cx="904875" cy="161925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884FEC4E-970B-40B9-8254-4D7996C89DB2}"/>
                </a:ext>
              </a:extLst>
            </p:cNvPr>
            <p:cNvSpPr/>
            <p:nvPr/>
          </p:nvSpPr>
          <p:spPr>
            <a:xfrm rot="20262567">
              <a:off x="4162425" y="3381375"/>
              <a:ext cx="533400" cy="200025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211D6240-490A-405E-8C78-A29FAC7D989B}"/>
                </a:ext>
              </a:extLst>
            </p:cNvPr>
            <p:cNvSpPr/>
            <p:nvPr/>
          </p:nvSpPr>
          <p:spPr>
            <a:xfrm>
              <a:off x="7377112" y="4852987"/>
              <a:ext cx="323850" cy="200025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: Rounded Corners 14">
              <a:extLst>
                <a:ext uri="{FF2B5EF4-FFF2-40B4-BE49-F238E27FC236}">
                  <a16:creationId xmlns:a16="http://schemas.microsoft.com/office/drawing/2014/main" id="{CD1D407D-B199-43DE-8445-28C547FE219A}"/>
                </a:ext>
              </a:extLst>
            </p:cNvPr>
            <p:cNvSpPr/>
            <p:nvPr/>
          </p:nvSpPr>
          <p:spPr>
            <a:xfrm rot="18867246">
              <a:off x="8517807" y="2961648"/>
              <a:ext cx="904875" cy="161925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1BFF0F72-031D-4731-8FF5-A4928A36237B}"/>
                </a:ext>
              </a:extLst>
            </p:cNvPr>
            <p:cNvSpPr/>
            <p:nvPr/>
          </p:nvSpPr>
          <p:spPr>
            <a:xfrm rot="19265041">
              <a:off x="4635037" y="4707647"/>
              <a:ext cx="533400" cy="200025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Diamond 17">
              <a:extLst>
                <a:ext uri="{FF2B5EF4-FFF2-40B4-BE49-F238E27FC236}">
                  <a16:creationId xmlns:a16="http://schemas.microsoft.com/office/drawing/2014/main" id="{E7A7E82C-8966-410A-A029-6EE519D0BC51}"/>
                </a:ext>
              </a:extLst>
            </p:cNvPr>
            <p:cNvSpPr/>
            <p:nvPr/>
          </p:nvSpPr>
          <p:spPr>
            <a:xfrm>
              <a:off x="5648101" y="4806803"/>
              <a:ext cx="381448" cy="428625"/>
            </a:xfrm>
            <a:prstGeom prst="diamond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0" name="Rectangle 19">
            <a:extLst>
              <a:ext uri="{FF2B5EF4-FFF2-40B4-BE49-F238E27FC236}">
                <a16:creationId xmlns:a16="http://schemas.microsoft.com/office/drawing/2014/main" id="{4C4272C7-6380-4E48-91C3-5DC56E5E5F9A}"/>
              </a:ext>
            </a:extLst>
          </p:cNvPr>
          <p:cNvSpPr/>
          <p:nvPr/>
        </p:nvSpPr>
        <p:spPr>
          <a:xfrm>
            <a:off x="2901826" y="4573395"/>
            <a:ext cx="7105475" cy="10821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i="1" dirty="0"/>
              <a:t>Fig. 3 Treatment of objects that cut by the edge from SEM image</a:t>
            </a:r>
          </a:p>
        </p:txBody>
      </p:sp>
    </p:spTree>
    <p:extLst>
      <p:ext uri="{BB962C8B-B14F-4D97-AF65-F5344CB8AC3E}">
        <p14:creationId xmlns:p14="http://schemas.microsoft.com/office/powerpoint/2010/main" val="33045572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62A8EB9D-DEA0-4727-A310-91E7D1F36EF7}"/>
              </a:ext>
            </a:extLst>
          </p:cNvPr>
          <p:cNvSpPr/>
          <p:nvPr/>
        </p:nvSpPr>
        <p:spPr>
          <a:xfrm>
            <a:off x="2020802" y="4058611"/>
            <a:ext cx="7105475" cy="10821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i="1" dirty="0"/>
              <a:t>Fig. 4 Synthesis Ag/TiO</a:t>
            </a:r>
            <a:r>
              <a:rPr lang="en-US" i="1" baseline="-25000" dirty="0"/>
              <a:t>2</a:t>
            </a:r>
            <a:r>
              <a:rPr lang="en-US" i="1" dirty="0"/>
              <a:t> nanocomposite materials using temperature and baking time (1000°C, 8 hours) as a parameter with three different zones of measurement. (a) zone 1, (b) zone 2, (c) zone 3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F65F7970-2D75-4A0C-8E09-4302BAC3DBA6}"/>
              </a:ext>
            </a:extLst>
          </p:cNvPr>
          <p:cNvGrpSpPr/>
          <p:nvPr/>
        </p:nvGrpSpPr>
        <p:grpSpPr>
          <a:xfrm>
            <a:off x="312187" y="320511"/>
            <a:ext cx="10126743" cy="3318039"/>
            <a:chOff x="312187" y="320511"/>
            <a:chExt cx="10126743" cy="3318039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1666F882-B54D-442F-8630-1ECA43DED0CF}"/>
                </a:ext>
              </a:extLst>
            </p:cNvPr>
            <p:cNvGrpSpPr/>
            <p:nvPr/>
          </p:nvGrpSpPr>
          <p:grpSpPr>
            <a:xfrm>
              <a:off x="1933738" y="3219450"/>
              <a:ext cx="7361022" cy="419100"/>
              <a:chOff x="1933738" y="3219450"/>
              <a:chExt cx="7361022" cy="419100"/>
            </a:xfrm>
          </p:grpSpPr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64AD8781-C200-415F-8A4C-A7928BDE27DA}"/>
                  </a:ext>
                </a:extLst>
              </p:cNvPr>
              <p:cNvSpPr/>
              <p:nvPr/>
            </p:nvSpPr>
            <p:spPr>
              <a:xfrm>
                <a:off x="1933738" y="3219450"/>
                <a:ext cx="558800" cy="4191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400" dirty="0">
                    <a:solidFill>
                      <a:schemeClr val="tx1"/>
                    </a:solidFill>
                  </a:rPr>
                  <a:t>(a)</a:t>
                </a: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0DE11C2A-0124-46BD-A07D-501F6D779122}"/>
                  </a:ext>
                </a:extLst>
              </p:cNvPr>
              <p:cNvSpPr/>
              <p:nvPr/>
            </p:nvSpPr>
            <p:spPr>
              <a:xfrm>
                <a:off x="5573540" y="3219450"/>
                <a:ext cx="558800" cy="4191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400" dirty="0">
                    <a:solidFill>
                      <a:schemeClr val="tx1"/>
                    </a:solidFill>
                  </a:rPr>
                  <a:t>(b)</a:t>
                </a: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9032601A-A6CA-4E9D-8916-ED8C506A68F8}"/>
                  </a:ext>
                </a:extLst>
              </p:cNvPr>
              <p:cNvSpPr/>
              <p:nvPr/>
            </p:nvSpPr>
            <p:spPr>
              <a:xfrm>
                <a:off x="8735960" y="3219450"/>
                <a:ext cx="558800" cy="4191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400" dirty="0">
                    <a:solidFill>
                      <a:schemeClr val="tx1"/>
                    </a:solidFill>
                  </a:rPr>
                  <a:t>(c)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3CD47778-949B-4F11-8E84-158221253D05}"/>
                </a:ext>
              </a:extLst>
            </p:cNvPr>
            <p:cNvGrpSpPr/>
            <p:nvPr/>
          </p:nvGrpSpPr>
          <p:grpSpPr>
            <a:xfrm>
              <a:off x="312187" y="320511"/>
              <a:ext cx="10126743" cy="2949341"/>
              <a:chOff x="312187" y="320511"/>
              <a:chExt cx="10126743" cy="2949341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F734C4E4-9615-4ACE-8ABB-F3A34D881CDB}"/>
                  </a:ext>
                </a:extLst>
              </p:cNvPr>
              <p:cNvGrpSpPr/>
              <p:nvPr/>
            </p:nvGrpSpPr>
            <p:grpSpPr>
              <a:xfrm>
                <a:off x="4169329" y="320511"/>
                <a:ext cx="6269601" cy="2949341"/>
                <a:chOff x="4161716" y="308209"/>
                <a:chExt cx="6269601" cy="2949341"/>
              </a:xfrm>
            </p:grpSpPr>
            <p:pic>
              <p:nvPicPr>
                <p:cNvPr id="5" name="Picture 4" descr="A picture containing road, black, water, sitting&#10;&#10;Description automatically generated">
                  <a:extLst>
                    <a:ext uri="{FF2B5EF4-FFF2-40B4-BE49-F238E27FC236}">
                      <a16:creationId xmlns:a16="http://schemas.microsoft.com/office/drawing/2014/main" id="{9A60F4F0-3A94-4029-9A3F-6AA4FC251CA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75" r="25032" b="3"/>
                <a:stretch/>
              </p:blipFill>
              <p:spPr>
                <a:xfrm>
                  <a:off x="7584178" y="308209"/>
                  <a:ext cx="2847139" cy="2949341"/>
                </a:xfrm>
                <a:prstGeom prst="rect">
                  <a:avLst/>
                </a:prstGeom>
              </p:spPr>
            </p:pic>
            <p:pic>
              <p:nvPicPr>
                <p:cNvPr id="6" name="Picture 5" descr="A close up of a logo&#10;&#10;Description automatically generated">
                  <a:extLst>
                    <a:ext uri="{FF2B5EF4-FFF2-40B4-BE49-F238E27FC236}">
                      <a16:creationId xmlns:a16="http://schemas.microsoft.com/office/drawing/2014/main" id="{06540998-8136-48EA-85FD-8622533FD3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244" t="-1" r="5021" b="4"/>
                <a:stretch/>
              </p:blipFill>
              <p:spPr>
                <a:xfrm>
                  <a:off x="4161716" y="308209"/>
                  <a:ext cx="3367223" cy="2949341"/>
                </a:xfrm>
                <a:prstGeom prst="rect">
                  <a:avLst/>
                </a:prstGeom>
              </p:spPr>
            </p:pic>
          </p:grpSp>
          <p:pic>
            <p:nvPicPr>
              <p:cNvPr id="18" name="Picture 17" descr="A picture containing table, indoor, pair, sitting&#10;&#10;Description automatically generated">
                <a:extLst>
                  <a:ext uri="{FF2B5EF4-FFF2-40B4-BE49-F238E27FC236}">
                    <a16:creationId xmlns:a16="http://schemas.microsoft.com/office/drawing/2014/main" id="{197CE857-E309-4541-A514-8191EA2E64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78" r="1315"/>
              <a:stretch/>
            </p:blipFill>
            <p:spPr>
              <a:xfrm>
                <a:off x="312187" y="320511"/>
                <a:ext cx="3801903" cy="2949341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9008389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62A8EB9D-DEA0-4727-A310-91E7D1F36EF7}"/>
              </a:ext>
            </a:extLst>
          </p:cNvPr>
          <p:cNvSpPr/>
          <p:nvPr/>
        </p:nvSpPr>
        <p:spPr>
          <a:xfrm>
            <a:off x="2592326" y="4671386"/>
            <a:ext cx="7105475" cy="10821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i="1" dirty="0"/>
              <a:t>Fig. 5 SEM image of Ag/TiO</a:t>
            </a:r>
            <a:r>
              <a:rPr lang="en-US" i="1" baseline="-25000" dirty="0"/>
              <a:t>2</a:t>
            </a:r>
            <a:r>
              <a:rPr lang="en-US" i="1" dirty="0"/>
              <a:t> nanocomposite material with different baking time. (a) 1200°C, 4 hours, (b) 1200°C, 6 hours, and (c) 1200°C, 8 hours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90B4B336-70F3-4A7E-82D9-74677CFDAC8B}"/>
              </a:ext>
            </a:extLst>
          </p:cNvPr>
          <p:cNvGrpSpPr/>
          <p:nvPr/>
        </p:nvGrpSpPr>
        <p:grpSpPr>
          <a:xfrm>
            <a:off x="268504" y="507534"/>
            <a:ext cx="11654992" cy="3829586"/>
            <a:chOff x="268504" y="507534"/>
            <a:chExt cx="11654992" cy="3829586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94027085-A1F6-490B-9730-D2AA77561BE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68504" y="507534"/>
              <a:ext cx="11654992" cy="3317521"/>
              <a:chOff x="79808" y="623001"/>
              <a:chExt cx="13813474" cy="3931920"/>
            </a:xfrm>
          </p:grpSpPr>
          <p:pic>
            <p:nvPicPr>
              <p:cNvPr id="16" name="Picture 15" descr="A picture containing rain, nature, road, lot&#10;&#10;Description automatically generated">
                <a:extLst>
                  <a:ext uri="{FF2B5EF4-FFF2-40B4-BE49-F238E27FC236}">
                    <a16:creationId xmlns:a16="http://schemas.microsoft.com/office/drawing/2014/main" id="{174082CC-E962-4C61-9B9E-706755BF23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10" r="5557"/>
              <a:stretch/>
            </p:blipFill>
            <p:spPr>
              <a:xfrm>
                <a:off x="79808" y="623001"/>
                <a:ext cx="4525346" cy="3931920"/>
              </a:xfrm>
              <a:prstGeom prst="rect">
                <a:avLst/>
              </a:prstGeom>
            </p:spPr>
          </p:pic>
          <p:pic>
            <p:nvPicPr>
              <p:cNvPr id="18" name="Picture 17" descr="A picture containing table, laptop, looking, sitting&#10;&#10;Description automatically generated">
                <a:extLst>
                  <a:ext uri="{FF2B5EF4-FFF2-40B4-BE49-F238E27FC236}">
                    <a16:creationId xmlns:a16="http://schemas.microsoft.com/office/drawing/2014/main" id="{CD0B5787-E398-4C07-8F9A-3448D4548F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32" r="5735"/>
              <a:stretch/>
            </p:blipFill>
            <p:spPr>
              <a:xfrm>
                <a:off x="4679800" y="623001"/>
                <a:ext cx="4525346" cy="3931920"/>
              </a:xfrm>
              <a:prstGeom prst="rect">
                <a:avLst/>
              </a:prstGeom>
            </p:spPr>
          </p:pic>
          <p:pic>
            <p:nvPicPr>
              <p:cNvPr id="20" name="Picture 19" descr="A picture containing table, computer, keyboard&#10;&#10;Description automatically generated">
                <a:extLst>
                  <a:ext uri="{FF2B5EF4-FFF2-40B4-BE49-F238E27FC236}">
                    <a16:creationId xmlns:a16="http://schemas.microsoft.com/office/drawing/2014/main" id="{6972ED63-8079-4BA1-B07D-A18674A9355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784" r="5100"/>
              <a:stretch/>
            </p:blipFill>
            <p:spPr>
              <a:xfrm>
                <a:off x="9279792" y="623001"/>
                <a:ext cx="4613490" cy="3931920"/>
              </a:xfrm>
              <a:prstGeom prst="rect">
                <a:avLst/>
              </a:prstGeom>
            </p:spPr>
          </p:pic>
        </p:grp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A9A73849-2646-497C-A3CF-F9D255BF3990}"/>
                </a:ext>
              </a:extLst>
            </p:cNvPr>
            <p:cNvSpPr/>
            <p:nvPr/>
          </p:nvSpPr>
          <p:spPr>
            <a:xfrm>
              <a:off x="1898213" y="3918020"/>
              <a:ext cx="558800" cy="4191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dirty="0">
                  <a:solidFill>
                    <a:schemeClr val="tx1"/>
                  </a:solidFill>
                </a:rPr>
                <a:t>(a)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1F09C30E-B43E-4909-83B3-B4023DFD2B03}"/>
                </a:ext>
              </a:extLst>
            </p:cNvPr>
            <p:cNvSpPr/>
            <p:nvPr/>
          </p:nvSpPr>
          <p:spPr>
            <a:xfrm>
              <a:off x="5779414" y="3918020"/>
              <a:ext cx="558800" cy="4191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dirty="0">
                  <a:solidFill>
                    <a:schemeClr val="tx1"/>
                  </a:solidFill>
                </a:rPr>
                <a:t>(b)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9E5BDBA1-F1D6-4994-91CA-3524A3EE9A79}"/>
                </a:ext>
              </a:extLst>
            </p:cNvPr>
            <p:cNvSpPr/>
            <p:nvPr/>
          </p:nvSpPr>
          <p:spPr>
            <a:xfrm>
              <a:off x="9697801" y="3918020"/>
              <a:ext cx="558800" cy="4191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dirty="0">
                  <a:solidFill>
                    <a:schemeClr val="tx1"/>
                  </a:solidFill>
                </a:rPr>
                <a:t>(c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03396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189</Words>
  <Application>Microsoft Office PowerPoint</Application>
  <PresentationFormat>Widescreen</PresentationFormat>
  <Paragraphs>2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hsin Muflikhun</dc:creator>
  <cp:lastModifiedBy>Akhsin Muflikhun</cp:lastModifiedBy>
  <cp:revision>16</cp:revision>
  <dcterms:created xsi:type="dcterms:W3CDTF">2019-11-07T06:29:27Z</dcterms:created>
  <dcterms:modified xsi:type="dcterms:W3CDTF">2019-11-12T01:02:49Z</dcterms:modified>
</cp:coreProperties>
</file>